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3" r:id="rId3"/>
    <p:sldId id="265" r:id="rId4"/>
    <p:sldId id="266" r:id="rId5"/>
  </p:sldIdLst>
  <p:sldSz cx="12192000" cy="6858000"/>
  <p:notesSz cx="6797675" cy="9928225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2621" autoAdjust="0"/>
  </p:normalViewPr>
  <p:slideViewPr>
    <p:cSldViewPr snapToGrid="0">
      <p:cViewPr varScale="1">
        <p:scale>
          <a:sx n="82" d="100"/>
          <a:sy n="82" d="100"/>
        </p:scale>
        <p:origin x="72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43452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8702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03814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11948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83600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52445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38676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83956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430576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33861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17678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49C09-F975-45A7-B396-FDE079B9E95E}" type="datetimeFigureOut">
              <a:rPr lang="da-DK" smtClean="0"/>
              <a:t>22-12-2015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E66EE-4D01-4E85-AD8E-9C222EA3EAC4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00187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GB" sz="3600" b="1" i="1" dirty="0"/>
              <a:t>Supplementary data</a:t>
            </a:r>
            <a:r>
              <a:rPr lang="da-DK" sz="3600" b="1" i="1" dirty="0"/>
              <a:t> for Re: Arthritis Research &amp; Therapy: 1228461238172039 Title: Early changes in blood-based joint tissue destruction biomarkers are predictive of response to tocilizumab in the LITHE </a:t>
            </a:r>
            <a:r>
              <a:rPr lang="da-DK" sz="3600" b="1" i="1" dirty="0" smtClean="0"/>
              <a:t>study</a:t>
            </a:r>
            <a:endParaRPr lang="da-DK" sz="3600" dirty="0"/>
          </a:p>
        </p:txBody>
      </p:sp>
      <p:sp>
        <p:nvSpPr>
          <p:cNvPr id="4" name="Subtitle 3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da-DK" b="1" i="1" dirty="0"/>
              <a:t>Authors: Anne C Bay-Jensen, Adam Platt, Anne Sofie Siebuhr, Inger Byrjalsen, Claus Christiansen and Morten A Karsdal</a:t>
            </a:r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4456165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smtClean="0"/>
              <a:t>Figure S1</a:t>
            </a:r>
            <a:endParaRPr lang="da-DK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2385679"/>
              </p:ext>
            </p:extLst>
          </p:nvPr>
        </p:nvGraphicFramePr>
        <p:xfrm>
          <a:off x="838200" y="1423534"/>
          <a:ext cx="7064375" cy="2755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0" name="Prism 6" r:id="rId3" imgW="9194672" imgH="3588817" progId="Prism6.Document">
                  <p:embed/>
                </p:oleObj>
              </mc:Choice>
              <mc:Fallback>
                <p:oleObj name="Prism 6" r:id="rId3" imgW="9194672" imgH="358881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8200" y="1423534"/>
                        <a:ext cx="7064375" cy="2755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222310" y="4422710"/>
            <a:ext cx="932128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</a:t>
            </a:r>
            <a:r>
              <a:rPr lang="en-GB" dirty="0" smtClean="0"/>
              <a:t>S1</a:t>
            </a:r>
            <a:r>
              <a:rPr lang="en-GB" dirty="0"/>
              <a:t>. Level of biomarker suppression in early responders (solid line) and non-responders (dotted line) in response to 8 mg/kg TCZ. Levels of A) </a:t>
            </a:r>
            <a:r>
              <a:rPr lang="en-GB" dirty="0" smtClean="0"/>
              <a:t>C-reactive protein (CRP), </a:t>
            </a:r>
            <a:r>
              <a:rPr lang="en-GB" dirty="0"/>
              <a:t>B) </a:t>
            </a:r>
            <a:r>
              <a:rPr lang="en-GB" dirty="0" smtClean="0"/>
              <a:t>matrix metalloproteinase 3 (MMP3), and </a:t>
            </a:r>
            <a:r>
              <a:rPr lang="en-GB" dirty="0"/>
              <a:t>C) </a:t>
            </a:r>
            <a:r>
              <a:rPr lang="en-GB" dirty="0" smtClean="0"/>
              <a:t>The ratio between bone resorption (CTX, C-terminal </a:t>
            </a:r>
            <a:r>
              <a:rPr lang="en-GB" dirty="0" err="1" smtClean="0"/>
              <a:t>telopeptide</a:t>
            </a:r>
            <a:r>
              <a:rPr lang="en-GB" dirty="0" smtClean="0"/>
              <a:t> of type I collagen) and bone formation (OC, osteocalcin). </a:t>
            </a:r>
            <a:r>
              <a:rPr lang="en-GB" dirty="0"/>
              <a:t>Data is shown as percentage change from baseline and mean ±SE</a:t>
            </a:r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7266687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lvl="0" eaLnBrk="0" fontAlgn="base" hangingPunct="0">
              <a:lnSpc>
                <a:spcPct val="100000"/>
              </a:lnSpc>
              <a:spcAft>
                <a:spcPct val="0"/>
              </a:spcAft>
            </a:pPr>
            <a:r>
              <a:rPr lang="en-GB" altLang="da-DK" sz="3200" dirty="0">
                <a:solidFill>
                  <a:srgbClr val="2E74B5"/>
                </a:solidFill>
                <a:latin typeface="Calibri Light" panose="020F03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Table S1 Summary statistics </a:t>
            </a:r>
            <a:r>
              <a:rPr lang="en-GB" altLang="da-DK" sz="3200" dirty="0" smtClean="0">
                <a:solidFill>
                  <a:srgbClr val="2E74B5"/>
                </a:solidFill>
                <a:latin typeface="Calibri Light" panose="020F03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table of the early responder and non-responders in the TCZ 8 mg/kg group</a:t>
            </a:r>
            <a:endParaRPr lang="da-DK" sz="32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6117274"/>
              </p:ext>
            </p:extLst>
          </p:nvPr>
        </p:nvGraphicFramePr>
        <p:xfrm>
          <a:off x="838200" y="1690688"/>
          <a:ext cx="10420358" cy="429391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247780"/>
                <a:gridCol w="355352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</a:tblGrid>
              <a:tr h="186692">
                <a:tc>
                  <a:txBody>
                    <a:bodyPr/>
                    <a:lstStyle/>
                    <a:p>
                      <a:r>
                        <a:rPr lang="da-DK" sz="800" dirty="0"/>
                        <a:t> </a:t>
                      </a:r>
                    </a:p>
                  </a:txBody>
                  <a:tcPr marL="15766" marR="15766" marT="7883" marB="7883" anchor="ctr"/>
                </a:tc>
                <a:tc gridSpan="6">
                  <a:txBody>
                    <a:bodyPr/>
                    <a:lstStyle/>
                    <a:p>
                      <a:r>
                        <a:rPr lang="da-DK" sz="800" dirty="0" smtClean="0"/>
                        <a:t>Early</a:t>
                      </a:r>
                      <a:r>
                        <a:rPr lang="da-DK" sz="800" baseline="0" dirty="0" smtClean="0"/>
                        <a:t> responders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r>
                        <a:rPr lang="da-DK" sz="800" dirty="0" smtClean="0"/>
                        <a:t>Early</a:t>
                      </a:r>
                      <a:r>
                        <a:rPr lang="da-DK" sz="800" baseline="0" dirty="0" smtClean="0"/>
                        <a:t> non-responders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</a:tr>
              <a:tr h="186692"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 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N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ean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SD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inimum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aximum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5 - 75 P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N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ean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SD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inimum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aximum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5 - 75 P</a:t>
                      </a:r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 dirty="0">
                          <a:effectLst/>
                        </a:rPr>
                        <a:t>C1M </a:t>
                      </a:r>
                      <a:r>
                        <a:rPr lang="da-DK" sz="800" dirty="0" smtClean="0">
                          <a:effectLst/>
                        </a:rPr>
                        <a:t>BL</a:t>
                      </a:r>
                      <a:endParaRPr lang="da-DK" sz="8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58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4.86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1.137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95.78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1.268 to 143.77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8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9.38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8.120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74.47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1.596 to 120.02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1M w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7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8.10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7.512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97.92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2.448 to 65.26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3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3.82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88.4178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89.8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2.862 to 91.42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 dirty="0">
                          <a:effectLst/>
                        </a:rPr>
                        <a:t>C1M, %-change </a:t>
                      </a:r>
                      <a:r>
                        <a:rPr lang="da-DK" sz="800" dirty="0" smtClean="0">
                          <a:effectLst/>
                        </a:rPr>
                        <a:t>wk4</a:t>
                      </a:r>
                      <a:endParaRPr lang="da-DK" sz="8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39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5.20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0.913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0.15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24.85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29.491 to 70.046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7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83.453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2.007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19.442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269.603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47.308 to 99.183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2M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8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55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93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8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84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36 to 0.63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3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56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258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7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48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20 to 0.66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2M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5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9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83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6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81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392 to 0.57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9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52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75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21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96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41 to 0.62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2M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5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0.32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7.443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52.991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95.17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7.542 to 97.5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9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1.23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2.659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1.83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80.28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3.060 to 110.26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3M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0.13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7.212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07.49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8.385 to 48.46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8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2.62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1.702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5.90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0.00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8.530 to 50.77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3M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76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1.72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5.662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7.73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1.720 to 37.74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36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7.03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0.919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.09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29.93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4.394 to 39.89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3M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43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9.66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1.290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1.96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49.99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0.309 to 92.41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7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0.50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2.231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7.92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64.73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6.071 to 103.79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03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15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456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4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9.5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677 to 2.67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40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.005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66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4.9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519 to 3.03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00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7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348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.1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60 to 0.19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09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.284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9.3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65 to 0.25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00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1.48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5.714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5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06.66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208 to 20.65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5.21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37.563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79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61.40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760 to 21.92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M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6.73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254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90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9.21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.403 to 20.00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8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7.95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.936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09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8.57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.777 to 19.66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M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76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2.59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776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.30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1.19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919 to 14.03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36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4.40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.489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.46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7.78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.647 to 17.33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M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43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8.65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3.914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6.78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47.70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8.906 to 90.35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7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5.81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2.381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4.89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49.04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2.332 to 98.70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TX/OC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8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3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123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065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78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149 to 0.029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3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18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112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046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7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114 to 0.022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TX/OC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7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2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132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047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0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42 to 0.0287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33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61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027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059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570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02 to 0.0188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TX/OC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7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9.48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0.789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7.07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92.94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0.619 to 113.46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33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6.08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3.049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0.97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45.18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7.317 to 121.02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MMP3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8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3.95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8.55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.3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24.93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4.122 to 72.77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3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4.86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4.160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.07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02.37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6.437 to 58.60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MMP3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7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4.51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8.185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.67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51.87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9.760 to 53.8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3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3.72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7.297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.0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92.82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5.350 to 48.61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 dirty="0">
                          <a:effectLst/>
                        </a:rPr>
                        <a:t>MMP3, %-change wk 4</a:t>
                      </a:r>
                      <a:endParaRPr lang="da-DK" sz="8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 dirty="0"/>
                        <a:t>17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84.484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46.2555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14.466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490.703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56.231 to 105.237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/>
                        <a:t>3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88.072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37.4134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19.784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174.984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63.080 to 114.368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582552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lvl="0" eaLnBrk="0" fontAlgn="base" hangingPunct="0">
              <a:lnSpc>
                <a:spcPct val="100000"/>
              </a:lnSpc>
              <a:spcAft>
                <a:spcPct val="0"/>
              </a:spcAft>
            </a:pPr>
            <a:r>
              <a:rPr lang="en-GB" altLang="da-DK" sz="3200" dirty="0">
                <a:solidFill>
                  <a:srgbClr val="2E74B5"/>
                </a:solidFill>
                <a:latin typeface="Calibri Light" panose="020F03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Table </a:t>
            </a:r>
            <a:r>
              <a:rPr lang="en-GB" altLang="da-DK" sz="3200" dirty="0" smtClean="0">
                <a:solidFill>
                  <a:srgbClr val="2E74B5"/>
                </a:solidFill>
                <a:latin typeface="Calibri Light" panose="020F03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2 </a:t>
            </a:r>
            <a:r>
              <a:rPr lang="en-GB" altLang="da-DK" sz="3200" dirty="0">
                <a:solidFill>
                  <a:srgbClr val="2E74B5"/>
                </a:solidFill>
                <a:latin typeface="Calibri Light" panose="020F03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mmary statistics </a:t>
            </a:r>
            <a:r>
              <a:rPr lang="en-GB" altLang="da-DK" sz="3200" dirty="0" smtClean="0">
                <a:solidFill>
                  <a:srgbClr val="2E74B5"/>
                </a:solidFill>
                <a:latin typeface="Calibri Light" panose="020F03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table of the early responder and non-responders in the TCZ 4 mg/kg group</a:t>
            </a:r>
            <a:endParaRPr lang="da-DK" sz="32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0140095"/>
              </p:ext>
            </p:extLst>
          </p:nvPr>
        </p:nvGraphicFramePr>
        <p:xfrm>
          <a:off x="838200" y="1690688"/>
          <a:ext cx="10420358" cy="429391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247780"/>
                <a:gridCol w="355352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  <a:gridCol w="801566"/>
              </a:tblGrid>
              <a:tr h="186692">
                <a:tc>
                  <a:txBody>
                    <a:bodyPr/>
                    <a:lstStyle/>
                    <a:p>
                      <a:r>
                        <a:rPr lang="da-DK" sz="800" dirty="0"/>
                        <a:t> </a:t>
                      </a:r>
                    </a:p>
                  </a:txBody>
                  <a:tcPr marL="15766" marR="15766" marT="7883" marB="7883" anchor="ctr"/>
                </a:tc>
                <a:tc gridSpan="6">
                  <a:txBody>
                    <a:bodyPr/>
                    <a:lstStyle/>
                    <a:p>
                      <a:r>
                        <a:rPr lang="da-DK" sz="800" dirty="0" smtClean="0"/>
                        <a:t>Early</a:t>
                      </a:r>
                      <a:r>
                        <a:rPr lang="da-DK" sz="800" baseline="0" dirty="0" smtClean="0"/>
                        <a:t> responders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r>
                        <a:rPr lang="da-DK" sz="800" dirty="0" smtClean="0"/>
                        <a:t>Early</a:t>
                      </a:r>
                      <a:r>
                        <a:rPr lang="da-DK" sz="800" baseline="0" dirty="0" smtClean="0"/>
                        <a:t> non-responders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</a:tr>
              <a:tr h="186692"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 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N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ean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SD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inimum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aximum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5 - 75 P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N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ean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SD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inimum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Maximum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25 - 75 P</a:t>
                      </a:r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 dirty="0">
                          <a:effectLst/>
                        </a:rPr>
                        <a:t>C1M </a:t>
                      </a:r>
                      <a:r>
                        <a:rPr lang="da-DK" sz="800" dirty="0" smtClean="0">
                          <a:effectLst/>
                        </a:rPr>
                        <a:t>BL</a:t>
                      </a:r>
                      <a:endParaRPr lang="da-DK" sz="8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5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5.83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9.854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80.84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5.687 to 124.08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8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22.52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9.903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8.33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04.55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1.553 to 146.74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1M w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3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1.33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9.748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51.6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0.314 to 120.24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0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2.45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3.755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8.75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17.19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3.566 to 131.92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 dirty="0">
                          <a:effectLst/>
                        </a:rPr>
                        <a:t>C1M, %-change </a:t>
                      </a:r>
                      <a:r>
                        <a:rPr lang="da-DK" sz="800" dirty="0" smtClean="0">
                          <a:effectLst/>
                        </a:rPr>
                        <a:t>wk4</a:t>
                      </a:r>
                      <a:endParaRPr lang="da-DK" sz="8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39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21.34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34.884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8.12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794.4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1.146 to 121.51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100.492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1.061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27.067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232.798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66.452 to 122.380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2M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55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79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5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43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42 to 0.62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53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47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25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03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45 to 0.60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2M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5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53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85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7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46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07 to 0.60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9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52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47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20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93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31 to 0.6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2M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5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9.79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9.185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3.05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72.54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6.470 to 105.28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9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8.76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4.678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4.90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29.02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9.204 to 110.48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3M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57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2.07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3.499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85.20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7.135 to 47.80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9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9.46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0.311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63.77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3.430 to 57.70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3M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8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1.04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0.518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31.36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6.340 to 53.78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7.54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8.571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0.12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81.74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0.920 to 53.15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3M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4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03.79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1.360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6.02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38.38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9.972 to 118.77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6.58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38.584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1.82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009.52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8.669 to 112.23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8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82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152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2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4.6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76 to 2.5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7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35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896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36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6.8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589 to 3.22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80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32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606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.93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283 to 1.79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95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.073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0.6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496 to 2.7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80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4.6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90.231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38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828.57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4.309 to 135.67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22.79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9.173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94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02.67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7.816 to 141.77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M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57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6.0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663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.60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3.50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.526 to 19.63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9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8.46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035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.72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4.38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3.863 to 22.76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M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8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5.77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728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.43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5.89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.064 to 19.07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7.72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.450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.53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3.10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2.487 to 18.52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RPM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4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01.69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7.938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2.70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01.56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8.192 to 119.08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4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08.55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4.18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2.92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96.59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1.917 to 118.09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TX/OC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75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23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475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0712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112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46 to 0.0280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/>
                        <a:t>5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212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155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059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10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130 to 0.024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TX/OC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209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097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053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770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35 to 0.0257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/>
                        <a:t>5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0.019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198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0531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629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0.0123 to 0.0220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CTX/OC, %-change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95.77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6.866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8.74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26.863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3.608 to 111.09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00.14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6.519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4.60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00.84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5.053 to 119.94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MMP3, BL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7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9.561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6.014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.56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99.4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1.990 to 59.3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2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44.038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3.4424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7.72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82.5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3.360 to 54.9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>
                          <a:effectLst/>
                        </a:rPr>
                        <a:t>MMP3, wk 4</a:t>
                      </a:r>
                      <a:endParaRPr lang="da-DK" sz="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4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5.76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2.176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.08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10.17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7.450 to 49.21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36.239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5.162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5.55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22.0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7.865 to 45.25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</a:tr>
              <a:tr h="186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a-DK" sz="800" dirty="0">
                          <a:effectLst/>
                        </a:rPr>
                        <a:t>MMP3, %-change wk 4</a:t>
                      </a:r>
                      <a:endParaRPr lang="da-DK" sz="8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3662" marR="53662" marT="0" marB="0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163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5.62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8.890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4.867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67.33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63.640 to 104.27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/>
                        <a:t>51</a:t>
                      </a:r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89.212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7.0606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25.170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>
                          <a:effectLst/>
                        </a:rPr>
                        <a:t>156.515</a:t>
                      </a:r>
                      <a:endParaRPr lang="da-DK" sz="800"/>
                    </a:p>
                  </a:txBody>
                  <a:tcPr marL="15766" marR="15766" marT="7883" marB="7883" anchor="ctr"/>
                </a:tc>
                <a:tc>
                  <a:txBody>
                    <a:bodyPr/>
                    <a:lstStyle/>
                    <a:p>
                      <a:r>
                        <a:rPr lang="da-DK" sz="800" dirty="0">
                          <a:effectLst/>
                        </a:rPr>
                        <a:t>68.614 to 106.694</a:t>
                      </a:r>
                      <a:endParaRPr lang="da-DK" sz="800" dirty="0"/>
                    </a:p>
                  </a:txBody>
                  <a:tcPr marL="15766" marR="15766" marT="7883" marB="7883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46491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1</TotalTime>
  <Words>1061</Words>
  <Application>Microsoft Office PowerPoint</Application>
  <PresentationFormat>Widescreen</PresentationFormat>
  <Paragraphs>584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SimSun</vt:lpstr>
      <vt:lpstr>Arial</vt:lpstr>
      <vt:lpstr>Calibri</vt:lpstr>
      <vt:lpstr>Calibri Light</vt:lpstr>
      <vt:lpstr>Times New Roman</vt:lpstr>
      <vt:lpstr>Office Theme</vt:lpstr>
      <vt:lpstr>GraphPad Prism 6 Project</vt:lpstr>
      <vt:lpstr>Supplementary data for Re: Arthritis Research &amp; Therapy: 1228461238172039 Title: Early changes in blood-based joint tissue destruction biomarkers are predictive of response to tocilizumab in the LITHE study</vt:lpstr>
      <vt:lpstr>Figure S1</vt:lpstr>
      <vt:lpstr>Table S1 Summary statistics table of the early responder and non-responders in the TCZ 8 mg/kg group</vt:lpstr>
      <vt:lpstr>Table S2 Summary statistics table of the early responder and non-responders in the TCZ 4 mg/kg group</vt:lpstr>
    </vt:vector>
  </TitlesOfParts>
  <Company>Nordic Bioscien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Anne-Christine Bay-Jensen</dc:creator>
  <cp:lastModifiedBy>Anne-Christine Bay-Jensen</cp:lastModifiedBy>
  <cp:revision>40</cp:revision>
  <cp:lastPrinted>2015-10-30T09:26:15Z</cp:lastPrinted>
  <dcterms:created xsi:type="dcterms:W3CDTF">2015-10-22T11:44:04Z</dcterms:created>
  <dcterms:modified xsi:type="dcterms:W3CDTF">2015-12-22T15:46:33Z</dcterms:modified>
</cp:coreProperties>
</file>